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charts/chart1.xml" ContentType="application/vnd.openxmlformats-officedocument.drawingml.char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barChart>
        <c:barDir val="col"/>
        <c:grouping val="clustered"/>
        <c:varyColors val="0"/>
        <c:ser>
          <c:idx val="0"/>
          <c:order val="0"/>
          <c:spPr>
            <a:solidFill>
              <a:srgbClr val="808080"/>
            </a:solidFill>
            <a:ln w="19080">
              <a:solidFill>
                <a:srgbClr val="000000"/>
              </a:solidFill>
              <a:round/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ser>
          <c:idx val="1"/>
          <c:order val="1"/>
          <c:spPr>
            <a:solidFill>
              <a:srgbClr val="008000"/>
            </a:solidFill>
            <a:ln w="19080">
              <a:solidFill>
                <a:srgbClr val="000000"/>
              </a:solidFill>
              <a:round/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ser>
          <c:idx val="2"/>
          <c:order val="2"/>
          <c:spPr>
            <a:solidFill>
              <a:srgbClr val="ff0000"/>
            </a:solidFill>
            <a:ln w="19080">
              <a:solidFill>
                <a:srgbClr val="000000"/>
              </a:solidFill>
              <a:round/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ser>
          <c:idx val="3"/>
          <c:order val="3"/>
          <c:spPr>
            <a:solidFill>
              <a:srgbClr val="660066"/>
            </a:solidFill>
            <a:ln w="19080">
              <a:solidFill>
                <a:srgbClr val="000000"/>
              </a:solidFill>
              <a:round/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gapWidth val="50"/>
        <c:overlap val="0"/>
        <c:axId val="23191044"/>
        <c:axId val="29736147"/>
      </c:barChart>
      <c:catAx>
        <c:axId val="2319104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spPr>
          <a:ln w="9360">
            <a:solidFill>
              <a:srgbClr val="878787"/>
            </a:solidFill>
            <a:round/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Calibri"/>
              </a:defRPr>
            </a:pPr>
          </a:p>
        </c:txPr>
        <c:crossAx val="29736147"/>
        <c:auto val="1"/>
        <c:lblAlgn val="ctr"/>
        <c:lblOffset val="100"/>
        <c:noMultiLvlLbl val="0"/>
      </c:catAx>
      <c:valAx>
        <c:axId val="29736147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spPr>
          <a:ln w="9360">
            <a:solidFill>
              <a:srgbClr val="878787"/>
            </a:solidFill>
            <a:round/>
          </a:ln>
        </c:spPr>
        <c:txPr>
          <a:bodyPr/>
          <a:lstStyle/>
          <a:p>
            <a:pPr>
              <a:defRPr b="0" sz="1000" spc="-1" strike="noStrike">
                <a:solidFill>
                  <a:srgbClr val="000000"/>
                </a:solidFill>
                <a:latin typeface="Calibri"/>
              </a:defRPr>
            </a:pPr>
          </a:p>
        </c:txPr>
        <c:crossAx val="23191044"/>
        <c:crossBetween val="between"/>
      </c:valAx>
      <c:spPr>
        <a:solidFill>
          <a:srgbClr val="ffffff"/>
        </a:solidFill>
        <a:ln w="0">
          <a:noFill/>
        </a:ln>
      </c:spPr>
    </c:plotArea>
    <c:legend>
      <c:legendPos val="r"/>
      <c:overlay val="0"/>
      <c:spPr>
        <a:noFill/>
        <a:ln w="0">
          <a:noFill/>
        </a:ln>
      </c:spPr>
      <c:txPr>
        <a:bodyPr/>
        <a:lstStyle/>
        <a:p>
          <a:pPr>
            <a:defRPr b="1" sz="1600" spc="-1" strike="noStrike">
              <a:solidFill>
                <a:srgbClr val="000000"/>
              </a:solidFill>
              <a:latin typeface="Arial"/>
            </a:defRPr>
          </a:pPr>
        </a:p>
      </c:txPr>
    </c:legend>
    <c:plotVisOnly val="1"/>
    <c:dispBlanksAs val="gap"/>
  </c:chart>
  <c:spPr>
    <a:solidFill>
      <a:srgbClr val="ffffff"/>
    </a:solidFill>
    <a:ln w="9360">
      <a:noFill/>
    </a:ln>
  </c:spPr>
</c:chartSpace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0F78BFF-4CF8-47B2-ABD4-2CAFE43DFF32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0EA5614-2CCE-4CCD-A24E-CFF1767EA8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4C9582C-9136-4E4D-B6D8-F7A6C659F3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C9130CA-A682-41EC-B72F-A11969E5EC22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6E91F6A1-E03B-4D72-9A19-F2F85AAC53BA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F5A83ED1-83CD-4073-B27F-EE68679C3D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44C90C5-2328-441E-A46C-C20120290E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3EFDA35E-9E81-4C49-8A47-850A10776D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D058A77-AEBC-4128-BD8F-1A0A7F269A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685800" y="2130120"/>
            <a:ext cx="7770960" cy="6807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FABA6A3F-1FDB-4FBD-A91A-0F10F1C3BB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BAE2645C-C809-479D-9A8E-37387A6952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35B1FEF-A502-48CC-A6B6-C0ED12E86A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BA9AD4E-C61A-4FE5-9FEF-4A8CA48A3C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C5AF54D6-90F6-4C3C-92D0-B0C1C73E7D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EE48A5F-03B4-499E-8780-99C2746BA7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065CA621-52CB-49B1-9385-F7F2E2D470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28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1360" y="16048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28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1360" y="396828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28AF726-D5EC-4E78-A199-3CFA39F99B5D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0A8FD35-AE1A-44F4-BC75-CB2DF2B2CA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8B4A23C-C9E0-4EBC-97DA-A54F02EDEC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E6710F2-1300-44B5-A8FA-77334BD81A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2130120"/>
            <a:ext cx="7770960" cy="6807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85577F2-1630-4CF1-986E-E73E2D281BF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1DD3771-1599-491B-A2C4-A51D84AF36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82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15359B6-D363-40C5-84E3-A92B596D5C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488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828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FFE8FC6-C66D-4A4A-8C32-57BE878181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0960" cy="1468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 idx="1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2/15/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sldNum" idx="2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FEF05327-3CC3-40B9-8E31-850DDE5496B8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457200" y="160488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99000"/>
          </a:bodyPr>
          <a:p>
            <a:pPr marL="3394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39480" indent="-3394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 fontScale="96000"/>
          </a:bodyPr>
          <a:p>
            <a:pPr marL="32904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29040" indent="-32904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3"/>
          </p:nvPr>
        </p:nvSpPr>
        <p:spPr>
          <a:xfrm>
            <a:off x="457200" y="6356160"/>
            <a:ext cx="213192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2/15/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sldNum" idx="4"/>
          </p:nvPr>
        </p:nvSpPr>
        <p:spPr>
          <a:xfrm>
            <a:off x="6552720" y="6356160"/>
            <a:ext cx="2132280" cy="3632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0491913F-B015-4A7A-9445-06FA3D1DF20A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19080" y="1440"/>
            <a:ext cx="9124920" cy="68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. 3  The number </a:t>
            </a:r>
            <a:r>
              <a:rPr b="1" lang="en-US" sz="1800" spc="-1" strike="noStrike">
                <a:solidFill>
                  <a:srgbClr val="000000"/>
                </a:solidFill>
                <a:latin typeface="Lucida Grande"/>
                <a:ea typeface="Lucida Grande"/>
              </a:rPr>
              <a:t>of stenotic arteries 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Lucida Grande"/>
              </a:rPr>
              <a:t>in each quartile by β2-Microglobulin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510000" y="1600200"/>
            <a:ext cx="1047600" cy="41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P &lt; 0.00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4" name=""/>
          <p:cNvGrpSpPr/>
          <p:nvPr/>
        </p:nvGrpSpPr>
        <p:grpSpPr>
          <a:xfrm>
            <a:off x="1600200" y="1125360"/>
            <a:ext cx="5403960" cy="3447360"/>
            <a:chOff x="1600200" y="1125360"/>
            <a:chExt cx="5403960" cy="3447360"/>
          </a:xfrm>
        </p:grpSpPr>
        <p:grpSp>
          <p:nvGrpSpPr>
            <p:cNvPr id="85" name=""/>
            <p:cNvGrpSpPr/>
            <p:nvPr/>
          </p:nvGrpSpPr>
          <p:grpSpPr>
            <a:xfrm>
              <a:off x="1900080" y="1125360"/>
              <a:ext cx="4003560" cy="3447360"/>
              <a:chOff x="1900080" y="1125360"/>
              <a:chExt cx="4003560" cy="3447360"/>
            </a:xfrm>
          </p:grpSpPr>
          <p:sp>
            <p:nvSpPr>
              <p:cNvPr id="86" name=""/>
              <p:cNvSpPr/>
              <p:nvPr/>
            </p:nvSpPr>
            <p:spPr>
              <a:xfrm>
                <a:off x="3351600" y="4160880"/>
                <a:ext cx="2552040" cy="411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t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1447920"/>
                    <a:tab algn="l" pos="217188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  <a:tab algn="l" pos="10058400"/>
                    <a:tab algn="l" pos="105156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β2-Microglobulin (mg/L)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 rot="16200000">
                <a:off x="1069200" y="2534400"/>
                <a:ext cx="2073240" cy="411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t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144792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  <a:tab algn="l" pos="10058400"/>
                    <a:tab algn="l" pos="105156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Calibri"/>
                  </a:rPr>
                  <a:t>In each quartile (%)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3071520" y="1189080"/>
                <a:ext cx="2754720" cy="411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t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23960"/>
                    <a:tab algn="l" pos="1447920"/>
                    <a:tab algn="l" pos="217188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  <a:tab algn="l" pos="9601200"/>
                    <a:tab algn="l" pos="10058400"/>
                    <a:tab algn="l" pos="105156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Calibri"/>
                  </a:rPr>
                  <a:t>Number of stenotic arterie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3294000" y="1125360"/>
                <a:ext cx="2338560" cy="747720"/>
              </a:xfrm>
              <a:prstGeom prst="rect">
                <a:avLst/>
              </a:prstGeom>
              <a:noFill/>
              <a:ln w="255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aphicFrame>
          <p:nvGraphicFramePr>
            <p:cNvPr id="90" name=""/>
            <p:cNvGraphicFramePr/>
            <p:nvPr/>
          </p:nvGraphicFramePr>
          <p:xfrm>
            <a:off x="1600200" y="1417680"/>
            <a:ext cx="5403960" cy="28749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"/>
            </a:graphicData>
          </a:graphic>
        </p:graphicFrame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